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5"/>
  </p:notesMasterIdLst>
  <p:sldIdLst>
    <p:sldId id="271" r:id="rId2"/>
    <p:sldId id="272" r:id="rId3"/>
    <p:sldId id="270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Figures" id="{2D1E3F90-FB61-4644-9C9A-A17BB153672B}">
          <p14:sldIdLst>
            <p14:sldId id="271"/>
            <p14:sldId id="272"/>
            <p14:sldId id="27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therine Horiot" initials="CH" lastIdx="21" clrIdx="0">
    <p:extLst>
      <p:ext uri="{19B8F6BF-5375-455C-9EA6-DF929625EA0E}">
        <p15:presenceInfo xmlns:p15="http://schemas.microsoft.com/office/powerpoint/2012/main" userId="S-1-5-21-1405975333-2736868122-3282660937-21427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F0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Style moyen 2 - Accentuatio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00" autoAdjust="0"/>
    <p:restoredTop sz="94814" autoAdjust="0"/>
  </p:normalViewPr>
  <p:slideViewPr>
    <p:cSldViewPr snapToGrid="0" showGuides="1">
      <p:cViewPr>
        <p:scale>
          <a:sx n="50" d="100"/>
          <a:sy n="50" d="100"/>
        </p:scale>
        <p:origin x="2208" y="12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mb-05.ad.unilim.fr\horiop01\Bureau\Manips\2022\Exp2022.04.20-GERMI\220428%20ELISA%20dosage%20hIgG%20sur%20Sn%20Exp20.04.2022-GERMI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smb-05.ad.unilim.fr\horiop01\Bureau\Manips\2022\Exp2022.04.21-MARFA\220428%20ELISA%20dosage%20hIgG%20sur%20Sn%20Exp21.04.2022-MARF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2"/>
          <c:tx>
            <c:v>Low dose CTR</c:v>
          </c:tx>
          <c:spPr>
            <a:ln w="19050" cap="rnd">
              <a:solidFill>
                <a:schemeClr val="accent5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40000"/>
                  <a:lumOff val="60000"/>
                </a:schemeClr>
              </a:solidFill>
              <a:ln w="9525">
                <a:solidFill>
                  <a:schemeClr val="accent5">
                    <a:lumMod val="40000"/>
                    <a:lumOff val="60000"/>
                  </a:schemeClr>
                </a:solidFill>
              </a:ln>
              <a:effectLst/>
            </c:spPr>
          </c:marker>
          <c:xVal>
            <c:numRef>
              <c:f>('Protocole + Analyse dil 2500e'!$A$131,'Protocole + Analyse dil 2500e'!$A$134,'Protocole + Analyse dil 2500e'!$A$137,'Protocole + Analyse dil 2500e'!$A$140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2500e'!$E$132,'Protocole + Analyse dil 2500e'!$E$135,'Protocole + Analyse dil 2500e'!$E$138,'Protocole + Analyse dil 2500e'!$E$141)</c:f>
              <c:numCache>
                <c:formatCode>0.00</c:formatCode>
                <c:ptCount val="4"/>
                <c:pt idx="0">
                  <c:v>5.2826086956521747</c:v>
                </c:pt>
                <c:pt idx="1">
                  <c:v>7.7826086956521729</c:v>
                </c:pt>
                <c:pt idx="2">
                  <c:v>24.413043478260871</c:v>
                </c:pt>
                <c:pt idx="3">
                  <c:v>45.2826086956521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818-4592-8A25-B173C7E98A0B}"/>
            </c:ext>
          </c:extLst>
        </c:ser>
        <c:ser>
          <c:idx val="3"/>
          <c:order val="3"/>
          <c:tx>
            <c:v>Low dose CTR'</c:v>
          </c:tx>
          <c:spPr>
            <a:ln w="19050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xVal>
            <c:numRef>
              <c:f>('Protocole + Analyse dil 2500e'!$A$131,'Protocole + Analyse dil 2500e'!$A$134,'Protocole + Analyse dil 2500e'!$A$137,'Protocole + Analyse dil 2500e'!$A$140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2500e'!$F$132,'Protocole + Analyse dil 2500e'!$F$135,'Protocole + Analyse dil 2500e'!$F$138,'Protocole + Analyse dil 2500e'!$F$141)</c:f>
              <c:numCache>
                <c:formatCode>0.00</c:formatCode>
                <c:ptCount val="4"/>
                <c:pt idx="0">
                  <c:v>4.6304347826086962</c:v>
                </c:pt>
                <c:pt idx="1">
                  <c:v>9.9565217391304355</c:v>
                </c:pt>
                <c:pt idx="2">
                  <c:v>32.239130434782602</c:v>
                </c:pt>
                <c:pt idx="3">
                  <c:v>33.4347826086956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818-4592-8A25-B173C7E98A0B}"/>
            </c:ext>
          </c:extLst>
        </c:ser>
        <c:ser>
          <c:idx val="4"/>
          <c:order val="4"/>
          <c:tx>
            <c:v>High dose CTR</c:v>
          </c:tx>
          <c:spPr>
            <a:ln w="19050" cap="rnd">
              <a:solidFill>
                <a:srgbClr val="FF9999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xVal>
            <c:numRef>
              <c:f>('Protocole + Analyse dil 2500e'!$A$131,'Protocole + Analyse dil 2500e'!$A$134,'Protocole + Analyse dil 2500e'!$A$137,'Protocole + Analyse dil 2500e'!$A$140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2500e'!$G$132,'Protocole + Analyse dil 2500e'!$G$135,'Protocole + Analyse dil 2500e'!$G$138,'Protocole + Analyse dil 2500e'!$G$141)</c:f>
              <c:numCache>
                <c:formatCode>0.00</c:formatCode>
                <c:ptCount val="4"/>
                <c:pt idx="0">
                  <c:v>5.1739130434782608</c:v>
                </c:pt>
                <c:pt idx="1">
                  <c:v>10.173913043478262</c:v>
                </c:pt>
                <c:pt idx="2">
                  <c:v>30.065217391304344</c:v>
                </c:pt>
                <c:pt idx="3">
                  <c:v>31.5869565217391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818-4592-8A25-B173C7E98A0B}"/>
            </c:ext>
          </c:extLst>
        </c:ser>
        <c:ser>
          <c:idx val="5"/>
          <c:order val="5"/>
          <c:tx>
            <c:v>High dose CTR'</c:v>
          </c:tx>
          <c:spPr>
            <a:ln w="19050" cap="rnd">
              <a:solidFill>
                <a:srgbClr val="FF7C8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7C80"/>
              </a:solidFill>
              <a:ln w="9525">
                <a:solidFill>
                  <a:srgbClr val="FF7C80"/>
                </a:solidFill>
              </a:ln>
              <a:effectLst/>
            </c:spPr>
          </c:marker>
          <c:xVal>
            <c:numRef>
              <c:f>('Protocole + Analyse dil 2500e'!$A$131,'Protocole + Analyse dil 2500e'!$A$134,'Protocole + Analyse dil 2500e'!$A$137,'Protocole + Analyse dil 2500e'!$A$140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2500e'!$H$132,'Protocole + Analyse dil 2500e'!$H$135,'Protocole + Analyse dil 2500e'!$H$138,'Protocole + Analyse dil 2500e'!$H$141)</c:f>
              <c:numCache>
                <c:formatCode>0.00</c:formatCode>
                <c:ptCount val="4"/>
                <c:pt idx="0">
                  <c:v>3.7608695652173907</c:v>
                </c:pt>
                <c:pt idx="1">
                  <c:v>7.4565217391304337</c:v>
                </c:pt>
                <c:pt idx="2">
                  <c:v>29.7391304347826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818-4592-8A25-B173C7E98A0B}"/>
            </c:ext>
          </c:extLst>
        </c:ser>
        <c:ser>
          <c:idx val="6"/>
          <c:order val="6"/>
          <c:tx>
            <c:v>Low dose ASO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('Protocole + Analyse dil 2500e'!$A$131,'Protocole + Analyse dil 2500e'!$A$134,'Protocole + Analyse dil 2500e'!$A$137,'Protocole + Analyse dil 2500e'!$A$140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2500e'!$I$132,'Protocole + Analyse dil 2500e'!$I$135,'Protocole + Analyse dil 2500e'!$I$138,'Protocole + Analyse dil 2500e'!$I$141)</c:f>
              <c:numCache>
                <c:formatCode>0.00</c:formatCode>
                <c:ptCount val="4"/>
                <c:pt idx="0">
                  <c:v>2.0217391304347831</c:v>
                </c:pt>
                <c:pt idx="1">
                  <c:v>5.2826086956521747</c:v>
                </c:pt>
                <c:pt idx="2">
                  <c:v>10.934782608695652</c:v>
                </c:pt>
                <c:pt idx="3">
                  <c:v>12.1304347826086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818-4592-8A25-B173C7E98A0B}"/>
            </c:ext>
          </c:extLst>
        </c:ser>
        <c:ser>
          <c:idx val="7"/>
          <c:order val="7"/>
          <c:tx>
            <c:v>Low dose ASO'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('Protocole + Analyse dil 2500e'!$A$131,'Protocole + Analyse dil 2500e'!$A$134,'Protocole + Analyse dil 2500e'!$A$137,'Protocole + Analyse dil 2500e'!$A$140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2500e'!$J$132,'Protocole + Analyse dil 2500e'!$J$135,'Protocole + Analyse dil 2500e'!$J$138,'Protocole + Analyse dil 2500e'!$J$141)</c:f>
              <c:numCache>
                <c:formatCode>0.00</c:formatCode>
                <c:ptCount val="4"/>
                <c:pt idx="0">
                  <c:v>3.2173913043478279</c:v>
                </c:pt>
                <c:pt idx="1">
                  <c:v>6.0434782608695672</c:v>
                </c:pt>
                <c:pt idx="2">
                  <c:v>11.478260869565219</c:v>
                </c:pt>
                <c:pt idx="3">
                  <c:v>11.5869565217391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818-4592-8A25-B173C7E98A0B}"/>
            </c:ext>
          </c:extLst>
        </c:ser>
        <c:ser>
          <c:idx val="8"/>
          <c:order val="8"/>
          <c:tx>
            <c:v>High dose ASO</c:v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xVal>
            <c:numRef>
              <c:f>('Protocole + Analyse dil 2500e'!$A$131,'Protocole + Analyse dil 2500e'!$A$134,'Protocole + Analyse dil 2500e'!$A$137,'Protocole + Analyse dil 2500e'!$A$140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2500e'!$K$132,'Protocole + Analyse dil 2500e'!$K$135,'Protocole + Analyse dil 2500e'!$K$138,'Protocole + Analyse dil 2500e'!$K$141)</c:f>
              <c:numCache>
                <c:formatCode>0.00</c:formatCode>
                <c:ptCount val="4"/>
                <c:pt idx="0">
                  <c:v>0.60869565217391386</c:v>
                </c:pt>
                <c:pt idx="1">
                  <c:v>2.2391304347826093</c:v>
                </c:pt>
                <c:pt idx="2">
                  <c:v>5.7173913043478279</c:v>
                </c:pt>
                <c:pt idx="3">
                  <c:v>5.28260869565217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1818-4592-8A25-B173C7E98A0B}"/>
            </c:ext>
          </c:extLst>
        </c:ser>
        <c:ser>
          <c:idx val="9"/>
          <c:order val="9"/>
          <c:tx>
            <c:v>High dose ASO'</c:v>
          </c:tx>
          <c:spPr>
            <a:ln w="19050" cap="rnd">
              <a:solidFill>
                <a:srgbClr val="99003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90033"/>
              </a:solidFill>
              <a:ln w="9525">
                <a:solidFill>
                  <a:srgbClr val="990033"/>
                </a:solidFill>
              </a:ln>
              <a:effectLst/>
            </c:spPr>
          </c:marker>
          <c:xVal>
            <c:numRef>
              <c:f>('Protocole + Analyse dil 2500e'!$A$131,'Protocole + Analyse dil 2500e'!$A$134,'Protocole + Analyse dil 2500e'!$A$137,'Protocole + Analyse dil 2500e'!$A$140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2500e'!$L$132,'Protocole + Analyse dil 2500e'!$L$135,'Protocole + Analyse dil 2500e'!$L$138,'Protocole + Analyse dil 2500e'!$L$141)</c:f>
              <c:numCache>
                <c:formatCode>0.00</c:formatCode>
                <c:ptCount val="4"/>
                <c:pt idx="0">
                  <c:v>2.1304347826086962</c:v>
                </c:pt>
                <c:pt idx="1">
                  <c:v>4.3043478260869561</c:v>
                </c:pt>
                <c:pt idx="2">
                  <c:v>4.4130434782608692</c:v>
                </c:pt>
                <c:pt idx="3">
                  <c:v>4.84782608695652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1818-4592-8A25-B173C7E98A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09357487"/>
        <c:axId val="1009421567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Protocole + Analyse dil 2500e'!$C$128:$C$130</c15:sqref>
                        </c15:formulaRef>
                      </c:ext>
                    </c:extLst>
                    <c:strCache>
                      <c:ptCount val="3"/>
                      <c:pt idx="0">
                        <c:v>1</c:v>
                      </c:pt>
                      <c:pt idx="1">
                        <c:v>NT</c:v>
                      </c:pt>
                      <c:pt idx="2">
                        <c:v>/</c:v>
                      </c:pt>
                    </c:strCache>
                  </c:strRef>
                </c:tx>
                <c:spPr>
                  <a:ln w="19050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('Protocole + Analyse dil 2500e'!$A$131,'Protocole + Analyse dil 2500e'!$A$134,'Protocole + Analyse dil 2500e'!$A$137,'Protocole + Analyse dil 2500e'!$A$140)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</c:v>
                      </c:pt>
                      <c:pt idx="1">
                        <c:v>2</c:v>
                      </c:pt>
                      <c:pt idx="2">
                        <c:v>5</c:v>
                      </c:pt>
                      <c:pt idx="3">
                        <c:v>7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('Protocole + Analyse dil 2500e'!$C$132,'Protocole + Analyse dil 2500e'!$C$135,'Protocole + Analyse dil 2500e'!$C$138,'Protocole + Analyse dil 2500e'!$C$141)</c15:sqref>
                        </c15:formulaRef>
                      </c:ext>
                    </c:extLst>
                    <c:numCache>
                      <c:formatCode>0.00</c:formatCode>
                      <c:ptCount val="4"/>
                      <c:pt idx="0">
                        <c:v>6.5869565217391326</c:v>
                      </c:pt>
                      <c:pt idx="1">
                        <c:v>11.586956521739133</c:v>
                      </c:pt>
                      <c:pt idx="2">
                        <c:v>44.304347826086953</c:v>
                      </c:pt>
                      <c:pt idx="3">
                        <c:v>55.826086956521735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8-1818-4592-8A25-B173C7E98A0B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rotocole + Analyse dil 2500e'!$D$128:$D$130</c15:sqref>
                        </c15:formulaRef>
                      </c:ext>
                    </c:extLst>
                    <c:strCache>
                      <c:ptCount val="3"/>
                      <c:pt idx="0">
                        <c:v>1'</c:v>
                      </c:pt>
                      <c:pt idx="1">
                        <c:v>NT</c:v>
                      </c:pt>
                      <c:pt idx="2">
                        <c:v>/</c:v>
                      </c:pt>
                    </c:strCache>
                  </c:strRef>
                </c:tx>
                <c:spPr>
                  <a:ln w="19050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('Protocole + Analyse dil 2500e'!$A$131,'Protocole + Analyse dil 2500e'!$A$134,'Protocole + Analyse dil 2500e'!$A$137,'Protocole + Analyse dil 2500e'!$A$140)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</c:v>
                      </c:pt>
                      <c:pt idx="1">
                        <c:v>2</c:v>
                      </c:pt>
                      <c:pt idx="2">
                        <c:v>5</c:v>
                      </c:pt>
                      <c:pt idx="3">
                        <c:v>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('Protocole + Analyse dil 2500e'!$D$132,'Protocole + Analyse dil 2500e'!$D$135,'Protocole + Analyse dil 2500e'!$D$138,'Protocole + Analyse dil 2500e'!$D$141)</c15:sqref>
                        </c15:formulaRef>
                      </c:ext>
                    </c:extLst>
                    <c:numCache>
                      <c:formatCode>0.00</c:formatCode>
                      <c:ptCount val="4"/>
                      <c:pt idx="0">
                        <c:v>5.0652173913043486</c:v>
                      </c:pt>
                      <c:pt idx="1">
                        <c:v>8.8695652173913064</c:v>
                      </c:pt>
                      <c:pt idx="2">
                        <c:v>34.413043478260867</c:v>
                      </c:pt>
                      <c:pt idx="3">
                        <c:v>49.30434782608694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1818-4592-8A25-B173C7E98A0B}"/>
                  </c:ext>
                </c:extLst>
              </c15:ser>
            </c15:filteredScatterSeries>
          </c:ext>
        </c:extLst>
      </c:scatterChart>
      <c:valAx>
        <c:axId val="1009357487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09421567"/>
        <c:crosses val="autoZero"/>
        <c:crossBetween val="midCat"/>
      </c:valAx>
      <c:valAx>
        <c:axId val="100942156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/>
                  <a:t>IgG</a:t>
                </a:r>
                <a:r>
                  <a:rPr lang="fr-FR" baseline="0" dirty="0"/>
                  <a:t> (µg/</a:t>
                </a:r>
                <a:r>
                  <a:rPr lang="fr-FR" baseline="0" dirty="0" err="1"/>
                  <a:t>mL</a:t>
                </a:r>
                <a:r>
                  <a:rPr lang="fr-FR" baseline="0" dirty="0"/>
                  <a:t>)</a:t>
                </a:r>
                <a:endParaRPr lang="fr-FR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cross"/>
        <c:minorTickMark val="in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09357487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2"/>
          <c:tx>
            <c:v>Low dose CTR</c:v>
          </c:tx>
          <c:spPr>
            <a:ln w="19050" cap="rnd">
              <a:solidFill>
                <a:schemeClr val="accent5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40000"/>
                  <a:lumOff val="60000"/>
                </a:schemeClr>
              </a:solidFill>
              <a:ln w="9525">
                <a:solidFill>
                  <a:schemeClr val="accent5">
                    <a:lumMod val="40000"/>
                    <a:lumOff val="60000"/>
                  </a:schemeClr>
                </a:solidFill>
              </a:ln>
              <a:effectLst/>
            </c:spPr>
          </c:marker>
          <c:xVal>
            <c:numRef>
              <c:f>('Protocole + Analyse dil 500e'!$A$131,'Protocole + Analyse dil 500e'!$A$134,'Protocole + Analyse dil 500e'!$A$137,'Protocole + Analyse dil 500e'!$A$140)</c:f>
              <c:numCache>
                <c:formatCode>General</c:formatCode>
                <c:ptCount val="4"/>
                <c:pt idx="0">
                  <c:v>1</c:v>
                </c:pt>
                <c:pt idx="1">
                  <c:v>4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500e'!$E$132,'Protocole + Analyse dil 500e'!$E$135,'Protocole + Analyse dil 500e'!$E$138,'Protocole + Analyse dil 500e'!$E$141)</c:f>
              <c:numCache>
                <c:formatCode>0.00</c:formatCode>
                <c:ptCount val="4"/>
                <c:pt idx="0">
                  <c:v>6.1441860465116296</c:v>
                </c:pt>
                <c:pt idx="1">
                  <c:v>16.888372093023257</c:v>
                </c:pt>
                <c:pt idx="2">
                  <c:v>21.423255813953489</c:v>
                </c:pt>
                <c:pt idx="3">
                  <c:v>27.1906976744186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56D-450D-8837-A111F3716DB6}"/>
            </c:ext>
          </c:extLst>
        </c:ser>
        <c:ser>
          <c:idx val="3"/>
          <c:order val="3"/>
          <c:tx>
            <c:v>Low dose CTR'</c:v>
          </c:tx>
          <c:spPr>
            <a:ln w="19050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xVal>
            <c:numRef>
              <c:f>('Protocole + Analyse dil 500e'!$A$131,'Protocole + Analyse dil 500e'!$A$134,'Protocole + Analyse dil 500e'!$A$137,'Protocole + Analyse dil 500e'!$A$140)</c:f>
              <c:numCache>
                <c:formatCode>General</c:formatCode>
                <c:ptCount val="4"/>
                <c:pt idx="0">
                  <c:v>1</c:v>
                </c:pt>
                <c:pt idx="1">
                  <c:v>4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500e'!$F$132,'Protocole + Analyse dil 500e'!$F$135,'Protocole + Analyse dil 500e'!$F$138,'Protocole + Analyse dil 500e'!$F$141)</c:f>
              <c:numCache>
                <c:formatCode>0.00</c:formatCode>
                <c:ptCount val="4"/>
                <c:pt idx="0">
                  <c:v>5.0279069767441866</c:v>
                </c:pt>
                <c:pt idx="1">
                  <c:v>18.70232558139535</c:v>
                </c:pt>
                <c:pt idx="2">
                  <c:v>25.167441860465118</c:v>
                </c:pt>
                <c:pt idx="3">
                  <c:v>29.0279069767441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56D-450D-8837-A111F3716DB6}"/>
            </c:ext>
          </c:extLst>
        </c:ser>
        <c:ser>
          <c:idx val="4"/>
          <c:order val="4"/>
          <c:tx>
            <c:v>High dose CTR</c:v>
          </c:tx>
          <c:spPr>
            <a:ln w="19050" cap="rnd">
              <a:solidFill>
                <a:srgbClr val="FFCCCC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CCCC"/>
              </a:solidFill>
              <a:ln w="9525">
                <a:solidFill>
                  <a:srgbClr val="FFCCCC"/>
                </a:solidFill>
              </a:ln>
              <a:effectLst/>
            </c:spPr>
          </c:marker>
          <c:xVal>
            <c:numRef>
              <c:f>('Protocole + Analyse dil 500e'!$A$131,'Protocole + Analyse dil 500e'!$A$134,'Protocole + Analyse dil 500e'!$A$137,'Protocole + Analyse dil 500e'!$A$140)</c:f>
              <c:numCache>
                <c:formatCode>General</c:formatCode>
                <c:ptCount val="4"/>
                <c:pt idx="0">
                  <c:v>1</c:v>
                </c:pt>
                <c:pt idx="1">
                  <c:v>4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500e'!$G$132,'Protocole + Analyse dil 500e'!$G$135,'Protocole + Analyse dil 500e'!$G$138,'Protocole + Analyse dil 500e'!$G$141)</c:f>
              <c:numCache>
                <c:formatCode>0.00</c:formatCode>
                <c:ptCount val="4"/>
                <c:pt idx="0">
                  <c:v>6.1441860465116296</c:v>
                </c:pt>
                <c:pt idx="1">
                  <c:v>16.423255813953489</c:v>
                </c:pt>
                <c:pt idx="2">
                  <c:v>20.074418604651164</c:v>
                </c:pt>
                <c:pt idx="3">
                  <c:v>25.7720930232558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56D-450D-8837-A111F3716DB6}"/>
            </c:ext>
          </c:extLst>
        </c:ser>
        <c:ser>
          <c:idx val="5"/>
          <c:order val="5"/>
          <c:tx>
            <c:v>High dose CTR'</c:v>
          </c:tx>
          <c:spPr>
            <a:ln w="19050" cap="rnd">
              <a:solidFill>
                <a:srgbClr val="FF9999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xVal>
            <c:numRef>
              <c:f>('Protocole + Analyse dil 500e'!$A$131,'Protocole + Analyse dil 500e'!$A$134,'Protocole + Analyse dil 500e'!$A$137,'Protocole + Analyse dil 500e'!$A$140)</c:f>
              <c:numCache>
                <c:formatCode>General</c:formatCode>
                <c:ptCount val="4"/>
                <c:pt idx="0">
                  <c:v>1</c:v>
                </c:pt>
                <c:pt idx="1">
                  <c:v>4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500e'!$H$132,'Protocole + Analyse dil 500e'!$H$135,'Protocole + Analyse dil 500e'!$H$138,'Protocole + Analyse dil 500e'!$H$141)</c:f>
              <c:numCache>
                <c:formatCode>0.00</c:formatCode>
                <c:ptCount val="4"/>
                <c:pt idx="0">
                  <c:v>5.8186046511627918</c:v>
                </c:pt>
                <c:pt idx="1">
                  <c:v>15.84186046511628</c:v>
                </c:pt>
                <c:pt idx="2">
                  <c:v>17.586046511627909</c:v>
                </c:pt>
                <c:pt idx="3">
                  <c:v>27.1674418604651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56D-450D-8837-A111F3716DB6}"/>
            </c:ext>
          </c:extLst>
        </c:ser>
        <c:ser>
          <c:idx val="6"/>
          <c:order val="6"/>
          <c:tx>
            <c:v>Low dose ASO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('Protocole + Analyse dil 500e'!$A$131,'Protocole + Analyse dil 500e'!$A$134,'Protocole + Analyse dil 500e'!$A$137,'Protocole + Analyse dil 500e'!$A$140)</c:f>
              <c:numCache>
                <c:formatCode>General</c:formatCode>
                <c:ptCount val="4"/>
                <c:pt idx="0">
                  <c:v>1</c:v>
                </c:pt>
                <c:pt idx="1">
                  <c:v>4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500e'!$I$132,'Protocole + Analyse dil 500e'!$I$135,'Protocole + Analyse dil 500e'!$I$138,'Protocole + Analyse dil 500e'!$I$141)</c:f>
              <c:numCache>
                <c:formatCode>0.00</c:formatCode>
                <c:ptCount val="4"/>
                <c:pt idx="0">
                  <c:v>4.1674418604651162</c:v>
                </c:pt>
                <c:pt idx="1">
                  <c:v>10.30697674418605</c:v>
                </c:pt>
                <c:pt idx="2">
                  <c:v>11.28372093023256</c:v>
                </c:pt>
                <c:pt idx="3">
                  <c:v>11.9581395348837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56D-450D-8837-A111F3716DB6}"/>
            </c:ext>
          </c:extLst>
        </c:ser>
        <c:ser>
          <c:idx val="7"/>
          <c:order val="7"/>
          <c:tx>
            <c:v>Low dose ASO'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('Protocole + Analyse dil 500e'!$A$131,'Protocole + Analyse dil 500e'!$A$134,'Protocole + Analyse dil 500e'!$A$137,'Protocole + Analyse dil 500e'!$A$140)</c:f>
              <c:numCache>
                <c:formatCode>General</c:formatCode>
                <c:ptCount val="4"/>
                <c:pt idx="0">
                  <c:v>1</c:v>
                </c:pt>
                <c:pt idx="1">
                  <c:v>4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500e'!$J$132,'Protocole + Analyse dil 500e'!$J$135,'Protocole + Analyse dil 500e'!$J$138,'Protocole + Analyse dil 500e'!$J$141)</c:f>
              <c:numCache>
                <c:formatCode>0.00</c:formatCode>
                <c:ptCount val="4"/>
                <c:pt idx="0">
                  <c:v>4.1906976744186046</c:v>
                </c:pt>
                <c:pt idx="1">
                  <c:v>9.4930232558139558</c:v>
                </c:pt>
                <c:pt idx="2">
                  <c:v>10.609302325581396</c:v>
                </c:pt>
                <c:pt idx="3">
                  <c:v>14.1209302325581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56D-450D-8837-A111F3716DB6}"/>
            </c:ext>
          </c:extLst>
        </c:ser>
        <c:ser>
          <c:idx val="8"/>
          <c:order val="8"/>
          <c:tx>
            <c:v>High dose ASO</c:v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xVal>
            <c:numRef>
              <c:f>('Protocole + Analyse dil 500e'!$A$131,'Protocole + Analyse dil 500e'!$A$134,'Protocole + Analyse dil 500e'!$A$137,'Protocole + Analyse dil 500e'!$A$140)</c:f>
              <c:numCache>
                <c:formatCode>General</c:formatCode>
                <c:ptCount val="4"/>
                <c:pt idx="0">
                  <c:v>1</c:v>
                </c:pt>
                <c:pt idx="1">
                  <c:v>4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500e'!$K$132,'Protocole + Analyse dil 500e'!$K$135,'Protocole + Analyse dil 500e'!$K$138,'Protocole + Analyse dil 500e'!$K$141)</c:f>
              <c:numCache>
                <c:formatCode>0.00</c:formatCode>
                <c:ptCount val="4"/>
                <c:pt idx="0">
                  <c:v>2.9348837209302321</c:v>
                </c:pt>
                <c:pt idx="1">
                  <c:v>5.1674418604651171</c:v>
                </c:pt>
                <c:pt idx="2">
                  <c:v>4.5395348837209299</c:v>
                </c:pt>
                <c:pt idx="3">
                  <c:v>8.586046511627907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956D-450D-8837-A111F3716DB6}"/>
            </c:ext>
          </c:extLst>
        </c:ser>
        <c:ser>
          <c:idx val="9"/>
          <c:order val="9"/>
          <c:tx>
            <c:v>High dose ASO'</c:v>
          </c:tx>
          <c:spPr>
            <a:ln w="19050" cap="rnd">
              <a:solidFill>
                <a:srgbClr val="99003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90033"/>
              </a:solidFill>
              <a:ln w="9525">
                <a:solidFill>
                  <a:srgbClr val="990033"/>
                </a:solidFill>
              </a:ln>
              <a:effectLst/>
            </c:spPr>
          </c:marker>
          <c:xVal>
            <c:numRef>
              <c:f>('Protocole + Analyse dil 500e'!$A$131,'Protocole + Analyse dil 500e'!$A$134,'Protocole + Analyse dil 500e'!$A$137,'Protocole + Analyse dil 500e'!$A$140)</c:f>
              <c:numCache>
                <c:formatCode>General</c:formatCode>
                <c:ptCount val="4"/>
                <c:pt idx="0">
                  <c:v>1</c:v>
                </c:pt>
                <c:pt idx="1">
                  <c:v>4</c:v>
                </c:pt>
                <c:pt idx="2">
                  <c:v>5</c:v>
                </c:pt>
                <c:pt idx="3">
                  <c:v>7</c:v>
                </c:pt>
              </c:numCache>
            </c:numRef>
          </c:xVal>
          <c:yVal>
            <c:numRef>
              <c:f>('Protocole + Analyse dil 500e'!$L$132,'Protocole + Analyse dil 500e'!$L$135,'Protocole + Analyse dil 500e'!$L$138,'Protocole + Analyse dil 500e'!$L$141)</c:f>
              <c:numCache>
                <c:formatCode>0.00</c:formatCode>
                <c:ptCount val="4"/>
                <c:pt idx="0">
                  <c:v>1.3069767441860467</c:v>
                </c:pt>
                <c:pt idx="1">
                  <c:v>5.7255813953488381</c:v>
                </c:pt>
                <c:pt idx="2">
                  <c:v>7.6093023255813961</c:v>
                </c:pt>
                <c:pt idx="3">
                  <c:v>6.91162790697674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956D-450D-8837-A111F3716D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09357487"/>
        <c:axId val="1009421567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Protocole + Analyse dil 500e'!$C$128:$C$130</c15:sqref>
                        </c15:formulaRef>
                      </c:ext>
                    </c:extLst>
                    <c:strCache>
                      <c:ptCount val="3"/>
                      <c:pt idx="0">
                        <c:v>1</c:v>
                      </c:pt>
                      <c:pt idx="1">
                        <c:v>NT</c:v>
                      </c:pt>
                      <c:pt idx="2">
                        <c:v>/</c:v>
                      </c:pt>
                    </c:strCache>
                  </c:strRef>
                </c:tx>
                <c:spPr>
                  <a:ln w="19050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('Protocole + Analyse dil 500e'!$A$131,'Protocole + Analyse dil 500e'!$A$134,'Protocole + Analyse dil 500e'!$A$137,'Protocole + Analyse dil 500e'!$A$140)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</c:v>
                      </c:pt>
                      <c:pt idx="1">
                        <c:v>4</c:v>
                      </c:pt>
                      <c:pt idx="2">
                        <c:v>5</c:v>
                      </c:pt>
                      <c:pt idx="3">
                        <c:v>7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('Protocole + Analyse dil 500e'!$C$132,'Protocole + Analyse dil 500e'!$C$135,'Protocole + Analyse dil 500e'!$C$138,'Protocole + Analyse dil 500e'!$C$141)</c15:sqref>
                        </c15:formulaRef>
                      </c:ext>
                    </c:extLst>
                    <c:numCache>
                      <c:formatCode>0.00</c:formatCode>
                      <c:ptCount val="4"/>
                      <c:pt idx="0">
                        <c:v>7.1674418604651162</c:v>
                      </c:pt>
                      <c:pt idx="1">
                        <c:v>27.865116279069767</c:v>
                      </c:pt>
                      <c:pt idx="2">
                        <c:v>32.539534883720933</c:v>
                      </c:pt>
                      <c:pt idx="3">
                        <c:v>41.237209302325581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8-956D-450D-8837-A111F3716DB6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rotocole + Analyse dil 500e'!$D$128:$D$130</c15:sqref>
                        </c15:formulaRef>
                      </c:ext>
                    </c:extLst>
                    <c:strCache>
                      <c:ptCount val="3"/>
                      <c:pt idx="0">
                        <c:v>1'</c:v>
                      </c:pt>
                      <c:pt idx="1">
                        <c:v>NT</c:v>
                      </c:pt>
                      <c:pt idx="2">
                        <c:v>/</c:v>
                      </c:pt>
                    </c:strCache>
                  </c:strRef>
                </c:tx>
                <c:spPr>
                  <a:ln w="19050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('Protocole + Analyse dil 500e'!$A$131,'Protocole + Analyse dil 500e'!$A$134,'Protocole + Analyse dil 500e'!$A$137,'Protocole + Analyse dil 500e'!$A$140)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</c:v>
                      </c:pt>
                      <c:pt idx="1">
                        <c:v>4</c:v>
                      </c:pt>
                      <c:pt idx="2">
                        <c:v>5</c:v>
                      </c:pt>
                      <c:pt idx="3">
                        <c:v>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('Protocole + Analyse dil 500e'!$D$132,'Protocole + Analyse dil 500e'!$D$135,'Protocole + Analyse dil 500e'!$D$138,'Protocole + Analyse dil 500e'!$D$141)</c15:sqref>
                        </c15:formulaRef>
                      </c:ext>
                    </c:extLst>
                    <c:numCache>
                      <c:formatCode>0.00</c:formatCode>
                      <c:ptCount val="4"/>
                      <c:pt idx="0">
                        <c:v>8.0511627906976759</c:v>
                      </c:pt>
                      <c:pt idx="1">
                        <c:v>29.027906976744188</c:v>
                      </c:pt>
                      <c:pt idx="2">
                        <c:v>33.981395348837211</c:v>
                      </c:pt>
                      <c:pt idx="3">
                        <c:v>40.934883720930237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956D-450D-8837-A111F3716DB6}"/>
                  </c:ext>
                </c:extLst>
              </c15:ser>
            </c15:filteredScatterSeries>
          </c:ext>
        </c:extLst>
      </c:scatterChart>
      <c:valAx>
        <c:axId val="1009357487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09421567"/>
        <c:crosses val="autoZero"/>
        <c:crossBetween val="midCat"/>
      </c:valAx>
      <c:valAx>
        <c:axId val="100942156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baseline="0" dirty="0"/>
                  <a:t>IgG (µg/</a:t>
                </a:r>
                <a:r>
                  <a:rPr lang="fr-FR" baseline="0" dirty="0" err="1"/>
                  <a:t>mL</a:t>
                </a:r>
                <a:r>
                  <a:rPr lang="fr-FR" baseline="0" dirty="0"/>
                  <a:t>)</a:t>
                </a:r>
                <a:endParaRPr lang="fr-FR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cross"/>
        <c:minorTickMark val="in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09357487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B91060-3C6F-41F5-A7F3-D7161534148F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C4CD67-00C4-4753-8987-4C215027E5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93499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8808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6645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23513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8278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8528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0978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68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5341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5149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6038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9604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8D3B5A-07F5-409C-8849-CDD8952549E8}" type="datetimeFigureOut">
              <a:rPr lang="fr-FR" smtClean="0"/>
              <a:t>29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5EE481-47A6-4B40-97CC-660625EC62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9193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013286" y="925032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1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376" y="3521784"/>
            <a:ext cx="5334000" cy="9906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736476" y="4468180"/>
            <a:ext cx="357215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spc="-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'-GTACCTTTATTTCGTGGGTCGCG-5'</a:t>
            </a:r>
            <a:endParaRPr lang="fr-FR" sz="900" b="1" spc="-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Connecteur droit 7"/>
          <p:cNvCxnSpPr/>
          <p:nvPr/>
        </p:nvCxnSpPr>
        <p:spPr>
          <a:xfrm>
            <a:off x="2950257" y="4455988"/>
            <a:ext cx="1508031" cy="0"/>
          </a:xfrm>
          <a:prstGeom prst="line">
            <a:avLst/>
          </a:prstGeom>
          <a:ln w="28575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à coins arrondis 8"/>
          <p:cNvSpPr/>
          <p:nvPr/>
        </p:nvSpPr>
        <p:spPr>
          <a:xfrm>
            <a:off x="3330278" y="3738352"/>
            <a:ext cx="408482" cy="655820"/>
          </a:xfrm>
          <a:prstGeom prst="roundRect">
            <a:avLst/>
          </a:prstGeom>
          <a:solidFill>
            <a:schemeClr val="accent1">
              <a:alpha val="27000"/>
            </a:schemeClr>
          </a:solidFill>
          <a:ln w="3175"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/>
          <p:cNvSpPr/>
          <p:nvPr/>
        </p:nvSpPr>
        <p:spPr>
          <a:xfrm>
            <a:off x="2139368" y="4468902"/>
            <a:ext cx="59710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spc="-100" dirty="0" smtClean="0">
                <a:latin typeface="Arial" panose="020B0604020202020204" pitchFamily="34" charset="0"/>
                <a:cs typeface="Arial" panose="020B0604020202020204" pitchFamily="34" charset="0"/>
              </a:rPr>
              <a:t>IgG-ASO</a:t>
            </a:r>
            <a:endParaRPr lang="fr-FR" sz="900" b="1" spc="-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3334834" y="3531766"/>
            <a:ext cx="403926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spc="-100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S</a:t>
            </a:r>
            <a:endParaRPr lang="fr-FR" sz="900" b="1" spc="-100" dirty="0">
              <a:solidFill>
                <a:schemeClr val="tx1">
                  <a:lumMod val="50000"/>
                  <a:lumOff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2101" y="5013972"/>
            <a:ext cx="5334000" cy="1114425"/>
          </a:xfrm>
          <a:prstGeom prst="rect">
            <a:avLst/>
          </a:prstGeom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42552A7D-99DC-4C10-81C3-839ADA5BABEF}"/>
              </a:ext>
            </a:extLst>
          </p:cNvPr>
          <p:cNvSpPr txBox="1"/>
          <p:nvPr/>
        </p:nvSpPr>
        <p:spPr>
          <a:xfrm>
            <a:off x="1160796" y="4717183"/>
            <a:ext cx="331305" cy="367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72572E5A-EA7D-45EF-A284-24DA9A4F517A}"/>
              </a:ext>
            </a:extLst>
          </p:cNvPr>
          <p:cNvSpPr txBox="1"/>
          <p:nvPr/>
        </p:nvSpPr>
        <p:spPr>
          <a:xfrm>
            <a:off x="1160796" y="2966686"/>
            <a:ext cx="331305" cy="367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5818415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 20"/>
          <p:cNvPicPr>
            <a:picLocks noChangeAspect="1"/>
          </p:cNvPicPr>
          <p:nvPr/>
        </p:nvPicPr>
        <p:blipFill rotWithShape="1">
          <a:blip r:embed="rId2"/>
          <a:srcRect b="19012"/>
          <a:stretch/>
        </p:blipFill>
        <p:spPr>
          <a:xfrm>
            <a:off x="1215956" y="3545164"/>
            <a:ext cx="3280226" cy="1748731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2956319" y="936685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2</a:t>
            </a:r>
            <a:endParaRPr lang="fr-FR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C0056F98-DCF0-4537-B51C-417A2FF5CA81}"/>
              </a:ext>
            </a:extLst>
          </p:cNvPr>
          <p:cNvSpPr txBox="1"/>
          <p:nvPr/>
        </p:nvSpPr>
        <p:spPr>
          <a:xfrm>
            <a:off x="2528487" y="3311486"/>
            <a:ext cx="4651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dirty="0">
                <a:cs typeface="Times New Roman" panose="02020603050405020304" pitchFamily="18" charset="0"/>
              </a:rPr>
              <a:t>NT</a:t>
            </a:r>
            <a:endParaRPr lang="fr-FR" sz="1100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2EA1D698-3A0F-434B-8C7A-71FD7DF26F84}"/>
              </a:ext>
            </a:extLst>
          </p:cNvPr>
          <p:cNvSpPr txBox="1"/>
          <p:nvPr/>
        </p:nvSpPr>
        <p:spPr>
          <a:xfrm>
            <a:off x="3151245" y="3177511"/>
            <a:ext cx="410010" cy="2223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dirty="0">
                <a:cs typeface="Times New Roman" panose="02020603050405020304" pitchFamily="18" charset="0"/>
              </a:rPr>
              <a:t>CTR</a:t>
            </a:r>
            <a:endParaRPr lang="fr-FR" sz="1100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88FBE247-E3DB-4C9A-860F-24D52DAB7069}"/>
              </a:ext>
            </a:extLst>
          </p:cNvPr>
          <p:cNvSpPr txBox="1"/>
          <p:nvPr/>
        </p:nvSpPr>
        <p:spPr>
          <a:xfrm>
            <a:off x="3860002" y="3160567"/>
            <a:ext cx="5807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dirty="0">
                <a:cs typeface="Times New Roman" panose="02020603050405020304" pitchFamily="18" charset="0"/>
              </a:rPr>
              <a:t>ASO</a:t>
            </a:r>
            <a:endParaRPr lang="fr-FR" sz="1100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A529417-2D34-4E60-8F58-1DB0D9DB60C1}"/>
              </a:ext>
            </a:extLst>
          </p:cNvPr>
          <p:cNvSpPr txBox="1"/>
          <p:nvPr/>
        </p:nvSpPr>
        <p:spPr>
          <a:xfrm>
            <a:off x="2987833" y="3311486"/>
            <a:ext cx="11364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err="1">
                <a:cs typeface="Times New Roman" panose="02020603050405020304" pitchFamily="18" charset="0"/>
              </a:rPr>
              <a:t>Low</a:t>
            </a:r>
            <a:r>
              <a:rPr lang="fr-FR" sz="1100" dirty="0">
                <a:cs typeface="Times New Roman" panose="02020603050405020304" pitchFamily="18" charset="0"/>
              </a:rPr>
              <a:t>  </a:t>
            </a:r>
            <a:r>
              <a:rPr lang="fr-FR" sz="1100" dirty="0" smtClean="0">
                <a:cs typeface="Times New Roman" panose="02020603050405020304" pitchFamily="18" charset="0"/>
              </a:rPr>
              <a:t> </a:t>
            </a:r>
            <a:r>
              <a:rPr lang="fr-FR" sz="1100" dirty="0">
                <a:cs typeface="Times New Roman" panose="02020603050405020304" pitchFamily="18" charset="0"/>
              </a:rPr>
              <a:t>High</a:t>
            </a:r>
            <a:endParaRPr lang="fr-FR" sz="1100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7A529417-2D34-4E60-8F58-1DB0D9DB60C1}"/>
              </a:ext>
            </a:extLst>
          </p:cNvPr>
          <p:cNvSpPr txBox="1"/>
          <p:nvPr/>
        </p:nvSpPr>
        <p:spPr>
          <a:xfrm>
            <a:off x="3768195" y="3304184"/>
            <a:ext cx="11363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err="1">
                <a:cs typeface="Times New Roman" panose="02020603050405020304" pitchFamily="18" charset="0"/>
              </a:rPr>
              <a:t>Low</a:t>
            </a:r>
            <a:r>
              <a:rPr lang="fr-FR" sz="1100" dirty="0">
                <a:cs typeface="Times New Roman" panose="02020603050405020304" pitchFamily="18" charset="0"/>
              </a:rPr>
              <a:t>  </a:t>
            </a:r>
            <a:r>
              <a:rPr lang="fr-FR" sz="1100" dirty="0" smtClean="0">
                <a:cs typeface="Times New Roman" panose="02020603050405020304" pitchFamily="18" charset="0"/>
              </a:rPr>
              <a:t> </a:t>
            </a:r>
            <a:r>
              <a:rPr lang="fr-FR" sz="1100" dirty="0">
                <a:cs typeface="Times New Roman" panose="02020603050405020304" pitchFamily="18" charset="0"/>
              </a:rPr>
              <a:t>High</a:t>
            </a:r>
            <a:endParaRPr lang="fr-FR" sz="1100" dirty="0"/>
          </a:p>
        </p:txBody>
      </p:sp>
      <p:sp>
        <p:nvSpPr>
          <p:cNvPr id="3" name="Rectangle 2"/>
          <p:cNvSpPr/>
          <p:nvPr/>
        </p:nvSpPr>
        <p:spPr>
          <a:xfrm>
            <a:off x="1046747" y="3838074"/>
            <a:ext cx="1481740" cy="457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6168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>
            <a:extLst>
              <a:ext uri="{FF2B5EF4-FFF2-40B4-BE49-F238E27FC236}">
                <a16:creationId xmlns:a16="http://schemas.microsoft.com/office/drawing/2014/main" id="{42552A7D-99DC-4C10-81C3-839ADA5BABEF}"/>
              </a:ext>
            </a:extLst>
          </p:cNvPr>
          <p:cNvSpPr txBox="1"/>
          <p:nvPr/>
        </p:nvSpPr>
        <p:spPr>
          <a:xfrm>
            <a:off x="622264" y="4854801"/>
            <a:ext cx="331305" cy="367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72572E5A-EA7D-45EF-A284-24DA9A4F517A}"/>
              </a:ext>
            </a:extLst>
          </p:cNvPr>
          <p:cNvSpPr txBox="1"/>
          <p:nvPr/>
        </p:nvSpPr>
        <p:spPr>
          <a:xfrm>
            <a:off x="622264" y="1086126"/>
            <a:ext cx="331305" cy="367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11" name="ZoneTexte 10"/>
          <p:cNvSpPr txBox="1"/>
          <p:nvPr/>
        </p:nvSpPr>
        <p:spPr>
          <a:xfrm>
            <a:off x="2956319" y="936685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3</a:t>
            </a:r>
            <a:endParaRPr lang="fr-FR" dirty="0"/>
          </a:p>
        </p:txBody>
      </p:sp>
      <p:graphicFrame>
        <p:nvGraphicFramePr>
          <p:cNvPr id="18" name="Graphique 17">
            <a:extLst>
              <a:ext uri="{FF2B5EF4-FFF2-40B4-BE49-F238E27FC236}">
                <a16:creationId xmlns:a16="http://schemas.microsoft.com/office/drawing/2014/main" id="{D33F7EA0-088E-41B3-943B-D60226D398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6508282"/>
              </p:ext>
            </p:extLst>
          </p:nvPr>
        </p:nvGraphicFramePr>
        <p:xfrm>
          <a:off x="953569" y="1270000"/>
          <a:ext cx="4672532" cy="33784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9" name="Graphique 18">
            <a:extLst>
              <a:ext uri="{FF2B5EF4-FFF2-40B4-BE49-F238E27FC236}">
                <a16:creationId xmlns:a16="http://schemas.microsoft.com/office/drawing/2014/main" id="{7A3706AF-20D1-49E4-A080-E6C4042472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7879544"/>
              </p:ext>
            </p:extLst>
          </p:nvPr>
        </p:nvGraphicFramePr>
        <p:xfrm>
          <a:off x="953569" y="5222549"/>
          <a:ext cx="4672532" cy="3461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0964539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79</TotalTime>
  <Words>33</Words>
  <Application>Microsoft Office PowerPoint</Application>
  <PresentationFormat>Format A4 (210 x 297 mm)</PresentationFormat>
  <Paragraphs>19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Horiot et al.</dc:title>
  <dc:creator>Catherine Horiot</dc:creator>
  <cp:lastModifiedBy>Laurent Delpy</cp:lastModifiedBy>
  <cp:revision>267</cp:revision>
  <dcterms:created xsi:type="dcterms:W3CDTF">2023-01-09T09:00:46Z</dcterms:created>
  <dcterms:modified xsi:type="dcterms:W3CDTF">2023-08-29T21:15:43Z</dcterms:modified>
</cp:coreProperties>
</file>